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jpeg" ContentType="image/jpeg"/>
  <Override PartName="/ppt/media/image11.jpeg" ContentType="image/jpeg"/>
  <Override PartName="/ppt/media/image13.jpeg" ContentType="image/jpeg"/>
  <Override PartName="/ppt/media/image8.jpeg" ContentType="image/jpeg"/>
  <Override PartName="/ppt/media/image10.jpeg" ContentType="image/jpeg"/>
  <Override PartName="/ppt/media/image12.jpeg" ContentType="image/jpeg"/>
  <Override PartName="/ppt/media/image7.jpeg" ContentType="image/jpeg"/>
  <Override PartName="/ppt/media/image6.jpeg" ContentType="image/jpeg"/>
  <Override PartName="/ppt/media/image5.jpeg" ContentType="image/jpeg"/>
  <Override PartName="/ppt/media/image21.jpeg" ContentType="image/jpeg"/>
  <Override PartName="/ppt/media/image16.jpeg" ContentType="image/jpeg"/>
  <Override PartName="/ppt/media/image20.jpeg" ContentType="image/jpeg"/>
  <Override PartName="/ppt/media/image15.jpeg" ContentType="image/jpeg"/>
  <Override PartName="/ppt/media/image19.jpeg" ContentType="image/jpeg"/>
  <Override PartName="/ppt/media/image18.jpeg" ContentType="image/jpeg"/>
  <Override PartName="/ppt/media/image17.jpeg" ContentType="image/jpeg"/>
  <Override PartName="/ppt/media/image1.jpeg" ContentType="image/jpeg"/>
  <Override PartName="/ppt/media/image22.jpeg" ContentType="image/jpeg"/>
  <Override PartName="/ppt/media/image14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82804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BB722A-B16C-4BB4-ADA2-F5E1035AFFF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14000" y="366480"/>
            <a:ext cx="745164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14000" y="2133360"/>
            <a:ext cx="745164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14000" y="5285160"/>
            <a:ext cx="745164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D88BF8-A5E3-43AB-87FE-F6B362A22FF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14000" y="366480"/>
            <a:ext cx="745164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14000" y="2133360"/>
            <a:ext cx="36363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232520" y="2133360"/>
            <a:ext cx="36363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14000" y="5285160"/>
            <a:ext cx="36363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232520" y="5285160"/>
            <a:ext cx="36363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2AB8CC-5CE6-4CEC-903D-BED9550B7D0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14000" y="366480"/>
            <a:ext cx="745164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14000" y="2133360"/>
            <a:ext cx="239904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933280" y="2133360"/>
            <a:ext cx="239904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452920" y="2133360"/>
            <a:ext cx="239904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14000" y="5285160"/>
            <a:ext cx="239904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933280" y="5285160"/>
            <a:ext cx="239904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452920" y="5285160"/>
            <a:ext cx="239904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D91A9A-DE1F-47EC-8103-6867EE9F82C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14000" y="366480"/>
            <a:ext cx="745164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14000" y="2133360"/>
            <a:ext cx="745164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1BECF6-4477-4C76-9DCD-052A212B84B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14000" y="366480"/>
            <a:ext cx="745164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14000" y="2133360"/>
            <a:ext cx="745164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A637F1-54EF-4139-9277-6F0E382B637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14000" y="366480"/>
            <a:ext cx="745164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14000" y="2133360"/>
            <a:ext cx="36363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232520" y="2133360"/>
            <a:ext cx="36363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AC13FC-3E75-44FC-A4D0-D9E6B34F2A5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14000" y="366480"/>
            <a:ext cx="745164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C0346A-CFF4-4C27-B62F-5659288F468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14000" y="366480"/>
            <a:ext cx="745164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EF28AA-8677-4E79-9F0D-8FD2FDE77B1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14000" y="366480"/>
            <a:ext cx="745164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14000" y="2133360"/>
            <a:ext cx="36363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232520" y="2133360"/>
            <a:ext cx="36363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14000" y="5285160"/>
            <a:ext cx="36363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1BCBC2-1100-4527-976C-7FDA52EADFC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14000" y="366480"/>
            <a:ext cx="745164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14000" y="2133360"/>
            <a:ext cx="36363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232520" y="2133360"/>
            <a:ext cx="36363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232520" y="5285160"/>
            <a:ext cx="36363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97294E-EF0C-4166-9A0D-AD3ED0FBE56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14000" y="366480"/>
            <a:ext cx="745164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14000" y="2133360"/>
            <a:ext cx="36363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232520" y="2133360"/>
            <a:ext cx="36363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14000" y="5285160"/>
            <a:ext cx="745164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7F2EA8-8813-4168-A725-FE97281B0B2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14000" y="366480"/>
            <a:ext cx="745164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14000" y="2133360"/>
            <a:ext cx="745164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14000" y="8326440"/>
            <a:ext cx="19321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828520" y="8326440"/>
            <a:ext cx="26226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934240" y="8326440"/>
            <a:ext cx="193176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D305645-2442-41A5-A5D4-20FC6D9CC07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jpeg"/><Relationship Id="rId10" Type="http://schemas.openxmlformats.org/officeDocument/2006/relationships/image" Target="../media/image10.jpeg"/><Relationship Id="rId11" Type="http://schemas.openxmlformats.org/officeDocument/2006/relationships/image" Target="../media/image11.jpeg"/><Relationship Id="rId12" Type="http://schemas.openxmlformats.org/officeDocument/2006/relationships/image" Target="../media/image12.jpeg"/><Relationship Id="rId13" Type="http://schemas.openxmlformats.org/officeDocument/2006/relationships/image" Target="../media/image13.jpeg"/><Relationship Id="rId14" Type="http://schemas.openxmlformats.org/officeDocument/2006/relationships/image" Target="../media/image14.jpeg"/><Relationship Id="rId15" Type="http://schemas.openxmlformats.org/officeDocument/2006/relationships/image" Target="../media/image15.jpeg"/><Relationship Id="rId16" Type="http://schemas.openxmlformats.org/officeDocument/2006/relationships/image" Target="../media/image16.jpeg"/><Relationship Id="rId17" Type="http://schemas.openxmlformats.org/officeDocument/2006/relationships/image" Target="../media/image17.jpeg"/><Relationship Id="rId18" Type="http://schemas.openxmlformats.org/officeDocument/2006/relationships/image" Target="../media/image18.jpeg"/><Relationship Id="rId19" Type="http://schemas.openxmlformats.org/officeDocument/2006/relationships/image" Target="../media/image19.jpeg"/><Relationship Id="rId20" Type="http://schemas.openxmlformats.org/officeDocument/2006/relationships/image" Target="../media/image20.jpeg"/><Relationship Id="rId21" Type="http://schemas.openxmlformats.org/officeDocument/2006/relationships/image" Target="../media/image21.jpeg"/><Relationship Id="rId22" Type="http://schemas.openxmlformats.org/officeDocument/2006/relationships/image" Target="../media/image22.jpeg"/><Relationship Id="rId2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44"/>
          <p:cNvSpPr/>
          <p:nvPr/>
        </p:nvSpPr>
        <p:spPr>
          <a:xfrm>
            <a:off x="4470480" y="1100160"/>
            <a:ext cx="3632040" cy="600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OC_Os10g40610  Flavin-binding monooxygenase-like protei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OC_Os01g58290  Subtilisin N-terminal Region family protei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OC_Os07g41580 CCAAT-binding transcription factor subunit A,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OC_Os09g25420 Zinc finger, C2H2 type family protei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OC_Os01g60770 expansin precursor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OC_Os07g07540 SHOOT1 protei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OC_Os08g45190 PGR5,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OC_Os03g29680 EARLY flowering 4 protei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OC_Os06g05060 early flowering 3, putative, expresse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OC_Os05g45910 conserved hypothetical protei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OC_Os11g10590 hypothetical protei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OC_Os04g17660 Rhodanese-like domain containing protei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OC_Os03g21820 Alpha-expansin 10 precursor, expressed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OC_Os03g51690 Homeobox protein OSH1,  expressed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OC_Os04g33570 CEN-like protein 2, expresse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OC_Os11g05470 CEN-like protein 3, expresse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OC_Os08g02070 Agamous-like MADS box protein AGL12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OC_Os01g18290 helix-loop-helix DNA-binding protei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OC_Os04g58200 protochlorophyllide reductase A,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OC_Os01g61500 BCL-2 binding anthanogene-1, expressed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OC_Os08g36320 Glutamate decarboxylase, putative, expresse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ct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49"/>
          <p:cNvSpPr/>
          <p:nvPr/>
        </p:nvSpPr>
        <p:spPr>
          <a:xfrm>
            <a:off x="1534680" y="673200"/>
            <a:ext cx="269532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      SI      YL    RT     RI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60"/>
          <p:cNvSpPr/>
          <p:nvPr/>
        </p:nvSpPr>
        <p:spPr>
          <a:xfrm>
            <a:off x="4267440" y="3638520"/>
            <a:ext cx="18360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Picture 43" descr="zt11-29-(4)"/>
          <p:cNvPicPr/>
          <p:nvPr/>
        </p:nvPicPr>
        <p:blipFill>
          <a:blip r:embed="rId1">
            <a:lum contrast="24000"/>
          </a:blip>
          <a:stretch/>
        </p:blipFill>
        <p:spPr>
          <a:xfrm>
            <a:off x="1473120" y="1054080"/>
            <a:ext cx="2817720" cy="26496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45" descr="zt11-29-(2)"/>
          <p:cNvPicPr/>
          <p:nvPr/>
        </p:nvPicPr>
        <p:blipFill>
          <a:blip r:embed="rId2">
            <a:lum contrast="18000"/>
          </a:blip>
          <a:stretch/>
        </p:blipFill>
        <p:spPr>
          <a:xfrm>
            <a:off x="1473120" y="1360440"/>
            <a:ext cx="2817720" cy="21924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46" descr="zt11-30-(3)-3"/>
          <p:cNvPicPr/>
          <p:nvPr/>
        </p:nvPicPr>
        <p:blipFill>
          <a:blip r:embed="rId3">
            <a:lum contrast="30000"/>
          </a:blip>
          <a:stretch/>
        </p:blipFill>
        <p:spPr>
          <a:xfrm>
            <a:off x="1473120" y="1622520"/>
            <a:ext cx="2817720" cy="19980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47" descr="zt11-29-(3)"/>
          <p:cNvPicPr/>
          <p:nvPr/>
        </p:nvPicPr>
        <p:blipFill>
          <a:blip r:embed="rId4">
            <a:lum contrast="36000"/>
          </a:blip>
          <a:stretch/>
        </p:blipFill>
        <p:spPr>
          <a:xfrm>
            <a:off x="1473120" y="1865160"/>
            <a:ext cx="2817720" cy="219240"/>
          </a:xfrm>
          <a:prstGeom prst="rect">
            <a:avLst/>
          </a:prstGeom>
          <a:ln w="0">
            <a:noFill/>
          </a:ln>
        </p:spPr>
      </p:pic>
      <p:pic>
        <p:nvPicPr>
          <p:cNvPr id="48" name="Picture 48" descr="zt11-30-(6)-5"/>
          <p:cNvPicPr/>
          <p:nvPr/>
        </p:nvPicPr>
        <p:blipFill>
          <a:blip r:embed="rId5">
            <a:lum contrast="24000"/>
          </a:blip>
          <a:stretch/>
        </p:blipFill>
        <p:spPr>
          <a:xfrm>
            <a:off x="1473120" y="2127240"/>
            <a:ext cx="2817720" cy="23508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50" descr="zt11-29-(6)"/>
          <p:cNvPicPr/>
          <p:nvPr/>
        </p:nvPicPr>
        <p:blipFill>
          <a:blip r:embed="rId6"/>
          <a:stretch/>
        </p:blipFill>
        <p:spPr>
          <a:xfrm>
            <a:off x="1473120" y="2405160"/>
            <a:ext cx="2817720" cy="25704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51" descr="zt11-30-(3)-5"/>
          <p:cNvPicPr/>
          <p:nvPr/>
        </p:nvPicPr>
        <p:blipFill>
          <a:blip r:embed="rId7">
            <a:lum contrast="42000"/>
          </a:blip>
          <a:stretch/>
        </p:blipFill>
        <p:spPr>
          <a:xfrm>
            <a:off x="1473120" y="2705040"/>
            <a:ext cx="2817720" cy="22068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52" descr="zt11-29-(7)"/>
          <p:cNvPicPr/>
          <p:nvPr/>
        </p:nvPicPr>
        <p:blipFill>
          <a:blip r:embed="rId8"/>
          <a:stretch/>
        </p:blipFill>
        <p:spPr>
          <a:xfrm>
            <a:off x="1473120" y="2968560"/>
            <a:ext cx="2817720" cy="28584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53" descr="zt11-30-(5)-1"/>
          <p:cNvPicPr/>
          <p:nvPr/>
        </p:nvPicPr>
        <p:blipFill>
          <a:blip r:embed="rId9">
            <a:lum contrast="36000"/>
          </a:blip>
          <a:stretch/>
        </p:blipFill>
        <p:spPr>
          <a:xfrm>
            <a:off x="1473120" y="3297240"/>
            <a:ext cx="2817720" cy="20808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54" descr="zt11-30-(6)-6"/>
          <p:cNvPicPr/>
          <p:nvPr/>
        </p:nvPicPr>
        <p:blipFill>
          <a:blip r:embed="rId10"/>
          <a:stretch/>
        </p:blipFill>
        <p:spPr>
          <a:xfrm>
            <a:off x="1473120" y="3546360"/>
            <a:ext cx="2817720" cy="23508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55" descr="zt11-30-(6)-1"/>
          <p:cNvPicPr/>
          <p:nvPr/>
        </p:nvPicPr>
        <p:blipFill>
          <a:blip r:embed="rId11"/>
          <a:stretch/>
        </p:blipFill>
        <p:spPr>
          <a:xfrm>
            <a:off x="1473120" y="3824280"/>
            <a:ext cx="2817720" cy="200160"/>
          </a:xfrm>
          <a:prstGeom prst="rect">
            <a:avLst/>
          </a:prstGeom>
          <a:ln w="0">
            <a:noFill/>
          </a:ln>
        </p:spPr>
      </p:pic>
      <p:pic>
        <p:nvPicPr>
          <p:cNvPr id="55" name="Picture 56" descr="zt11-30-(6)-4"/>
          <p:cNvPicPr/>
          <p:nvPr/>
        </p:nvPicPr>
        <p:blipFill>
          <a:blip r:embed="rId12">
            <a:lum contrast="54000"/>
          </a:blip>
          <a:stretch/>
        </p:blipFill>
        <p:spPr>
          <a:xfrm>
            <a:off x="1473120" y="4067280"/>
            <a:ext cx="2817720" cy="234720"/>
          </a:xfrm>
          <a:prstGeom prst="rect">
            <a:avLst/>
          </a:prstGeom>
          <a:ln w="0">
            <a:noFill/>
          </a:ln>
        </p:spPr>
      </p:pic>
      <p:pic>
        <p:nvPicPr>
          <p:cNvPr id="56" name="Picture 57" descr="zt11-30-(6)-5"/>
          <p:cNvPicPr/>
          <p:nvPr/>
        </p:nvPicPr>
        <p:blipFill>
          <a:blip r:embed="rId13">
            <a:lum contrast="48000"/>
          </a:blip>
          <a:stretch/>
        </p:blipFill>
        <p:spPr>
          <a:xfrm>
            <a:off x="1473120" y="4344840"/>
            <a:ext cx="2817720" cy="235080"/>
          </a:xfrm>
          <a:prstGeom prst="rect">
            <a:avLst/>
          </a:prstGeom>
          <a:ln w="0">
            <a:noFill/>
          </a:ln>
        </p:spPr>
      </p:pic>
      <p:pic>
        <p:nvPicPr>
          <p:cNvPr id="57" name="Picture 58" descr="zt11-30-(6)-7"/>
          <p:cNvPicPr/>
          <p:nvPr/>
        </p:nvPicPr>
        <p:blipFill>
          <a:blip r:embed="rId14"/>
          <a:stretch/>
        </p:blipFill>
        <p:spPr>
          <a:xfrm>
            <a:off x="1473120" y="4622760"/>
            <a:ext cx="2817720" cy="276120"/>
          </a:xfrm>
          <a:prstGeom prst="rect">
            <a:avLst/>
          </a:prstGeom>
          <a:ln w="0">
            <a:noFill/>
          </a:ln>
        </p:spPr>
      </p:pic>
      <p:pic>
        <p:nvPicPr>
          <p:cNvPr id="58" name="Picture 73" descr="zt11-30-(6)-2"/>
          <p:cNvPicPr/>
          <p:nvPr/>
        </p:nvPicPr>
        <p:blipFill>
          <a:blip r:embed="rId15"/>
          <a:stretch/>
        </p:blipFill>
        <p:spPr>
          <a:xfrm>
            <a:off x="1473120" y="4941720"/>
            <a:ext cx="2817720" cy="266760"/>
          </a:xfrm>
          <a:prstGeom prst="rect">
            <a:avLst/>
          </a:prstGeom>
          <a:ln w="0">
            <a:noFill/>
          </a:ln>
        </p:spPr>
      </p:pic>
      <p:pic>
        <p:nvPicPr>
          <p:cNvPr id="59" name="Picture 41" descr="zt11-29-(5)"/>
          <p:cNvPicPr/>
          <p:nvPr/>
        </p:nvPicPr>
        <p:blipFill>
          <a:blip r:embed="rId16"/>
          <a:stretch/>
        </p:blipFill>
        <p:spPr>
          <a:xfrm>
            <a:off x="1473120" y="6873840"/>
            <a:ext cx="2817720" cy="236520"/>
          </a:xfrm>
          <a:prstGeom prst="rect">
            <a:avLst/>
          </a:prstGeom>
          <a:ln w="0">
            <a:noFill/>
          </a:ln>
        </p:spPr>
      </p:pic>
      <p:pic>
        <p:nvPicPr>
          <p:cNvPr id="60" name="Picture 75" descr="zt12-1-(5)-3"/>
          <p:cNvPicPr/>
          <p:nvPr/>
        </p:nvPicPr>
        <p:blipFill>
          <a:blip r:embed="rId17">
            <a:lum contrast="30000"/>
          </a:blip>
          <a:stretch/>
        </p:blipFill>
        <p:spPr>
          <a:xfrm>
            <a:off x="1473120" y="5557680"/>
            <a:ext cx="2817720" cy="214560"/>
          </a:xfrm>
          <a:prstGeom prst="rect">
            <a:avLst/>
          </a:prstGeom>
          <a:ln w="0">
            <a:noFill/>
          </a:ln>
        </p:spPr>
      </p:pic>
      <p:pic>
        <p:nvPicPr>
          <p:cNvPr id="61" name="Picture 76" descr="zt12-1-(3)-9"/>
          <p:cNvPicPr/>
          <p:nvPr/>
        </p:nvPicPr>
        <p:blipFill>
          <a:blip r:embed="rId18"/>
          <a:stretch/>
        </p:blipFill>
        <p:spPr>
          <a:xfrm>
            <a:off x="1473120" y="5815080"/>
            <a:ext cx="2817720" cy="231840"/>
          </a:xfrm>
          <a:prstGeom prst="rect">
            <a:avLst/>
          </a:prstGeom>
          <a:ln w="0">
            <a:noFill/>
          </a:ln>
        </p:spPr>
      </p:pic>
      <p:pic>
        <p:nvPicPr>
          <p:cNvPr id="62" name="Picture 81" descr="zt11-30-(3)-4"/>
          <p:cNvPicPr/>
          <p:nvPr/>
        </p:nvPicPr>
        <p:blipFill>
          <a:blip r:embed="rId19"/>
          <a:stretch/>
        </p:blipFill>
        <p:spPr>
          <a:xfrm>
            <a:off x="1473120" y="6056280"/>
            <a:ext cx="2817720" cy="257040"/>
          </a:xfrm>
          <a:prstGeom prst="rect">
            <a:avLst/>
          </a:prstGeom>
          <a:ln w="0">
            <a:noFill/>
          </a:ln>
        </p:spPr>
      </p:pic>
      <p:pic>
        <p:nvPicPr>
          <p:cNvPr id="63" name="Picture 84" descr="zt11-30-(5)-2"/>
          <p:cNvPicPr/>
          <p:nvPr/>
        </p:nvPicPr>
        <p:blipFill>
          <a:blip r:embed="rId20"/>
          <a:stretch/>
        </p:blipFill>
        <p:spPr>
          <a:xfrm>
            <a:off x="1473120" y="6356520"/>
            <a:ext cx="2817720" cy="209520"/>
          </a:xfrm>
          <a:prstGeom prst="rect">
            <a:avLst/>
          </a:prstGeom>
          <a:ln w="0">
            <a:noFill/>
          </a:ln>
        </p:spPr>
      </p:pic>
      <p:pic>
        <p:nvPicPr>
          <p:cNvPr id="64" name="Picture 91" descr="zt11-30-(5)-5"/>
          <p:cNvPicPr/>
          <p:nvPr/>
        </p:nvPicPr>
        <p:blipFill>
          <a:blip r:embed="rId21"/>
          <a:stretch/>
        </p:blipFill>
        <p:spPr>
          <a:xfrm>
            <a:off x="1473120" y="6616800"/>
            <a:ext cx="2817720" cy="214200"/>
          </a:xfrm>
          <a:prstGeom prst="rect">
            <a:avLst/>
          </a:prstGeom>
          <a:ln w="0">
            <a:noFill/>
          </a:ln>
        </p:spPr>
      </p:pic>
      <p:pic>
        <p:nvPicPr>
          <p:cNvPr id="65" name="Picture 100" descr="zt11-30-(6)-3"/>
          <p:cNvPicPr/>
          <p:nvPr/>
        </p:nvPicPr>
        <p:blipFill>
          <a:blip r:embed="rId22"/>
          <a:stretch/>
        </p:blipFill>
        <p:spPr>
          <a:xfrm>
            <a:off x="1473120" y="5251320"/>
            <a:ext cx="2819520" cy="263520"/>
          </a:xfrm>
          <a:prstGeom prst="rect">
            <a:avLst/>
          </a:prstGeom>
          <a:ln w="0">
            <a:noFill/>
          </a:ln>
        </p:spPr>
      </p:pic>
      <p:sp>
        <p:nvSpPr>
          <p:cNvPr id="66" name="Rectangle 58"/>
          <p:cNvSpPr/>
          <p:nvPr/>
        </p:nvSpPr>
        <p:spPr>
          <a:xfrm>
            <a:off x="711360" y="7391520"/>
            <a:ext cx="6858000" cy="929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7040" rIns="77040" tIns="38520" bIns="385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Additional file 7. 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The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RT-PCR profiles of 21 selected tissue-specifically expressed genes. RI, YL, RT, ST and SI represent rhizome internodes, young leaves, rhizome tips, shoot tips and shoot internodes.  * indicates the genes’ RT-PCR patterns failed to confirm their expression patterns in the microarray data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AutoShape 113"/>
          <p:cNvSpPr/>
          <p:nvPr/>
        </p:nvSpPr>
        <p:spPr>
          <a:xfrm>
            <a:off x="1244520" y="1143000"/>
            <a:ext cx="152640" cy="1066680"/>
          </a:xfrm>
          <a:custGeom>
            <a:avLst/>
            <a:gdLst>
              <a:gd name="textAreaLeft" fmla="*/ 97560 w 152640"/>
              <a:gd name="textAreaRight" fmla="*/ 153000 w 152640"/>
              <a:gd name="textAreaTop" fmla="*/ 27720 h 1066680"/>
              <a:gd name="textAreaBottom" fmla="*/ 1038960 h 106668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114"/>
          <p:cNvSpPr/>
          <p:nvPr/>
        </p:nvSpPr>
        <p:spPr>
          <a:xfrm>
            <a:off x="105120" y="1498680"/>
            <a:ext cx="1035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I-enriche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AutoShape 115"/>
          <p:cNvSpPr/>
          <p:nvPr/>
        </p:nvSpPr>
        <p:spPr>
          <a:xfrm>
            <a:off x="1244520" y="2514600"/>
            <a:ext cx="152640" cy="1143000"/>
          </a:xfrm>
          <a:custGeom>
            <a:avLst/>
            <a:gdLst>
              <a:gd name="textAreaLeft" fmla="*/ 97560 w 152640"/>
              <a:gd name="textAreaRight" fmla="*/ 153000 w 152640"/>
              <a:gd name="textAreaTop" fmla="*/ 29520 h 1143000"/>
              <a:gd name="textAreaBottom" fmla="*/ 1113480 h 11430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116"/>
          <p:cNvSpPr/>
          <p:nvPr/>
        </p:nvSpPr>
        <p:spPr>
          <a:xfrm>
            <a:off x="124560" y="2946240"/>
            <a:ext cx="1093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YL-enriche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AutoShape 117"/>
          <p:cNvSpPr/>
          <p:nvPr/>
        </p:nvSpPr>
        <p:spPr>
          <a:xfrm>
            <a:off x="1244520" y="3962520"/>
            <a:ext cx="76320" cy="1904760"/>
          </a:xfrm>
          <a:custGeom>
            <a:avLst/>
            <a:gdLst>
              <a:gd name="textAreaLeft" fmla="*/ 48960 w 76320"/>
              <a:gd name="textAreaRight" fmla="*/ 76320 w 76320"/>
              <a:gd name="textAreaTop" fmla="*/ 49680 h 1904760"/>
              <a:gd name="textAreaBottom" fmla="*/ 1855080 h 190476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118"/>
          <p:cNvSpPr/>
          <p:nvPr/>
        </p:nvSpPr>
        <p:spPr>
          <a:xfrm>
            <a:off x="92160" y="4775040"/>
            <a:ext cx="1084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T-enriche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AutoShape 119"/>
          <p:cNvSpPr/>
          <p:nvPr/>
        </p:nvSpPr>
        <p:spPr>
          <a:xfrm>
            <a:off x="1244520" y="6172200"/>
            <a:ext cx="76320" cy="533520"/>
          </a:xfrm>
          <a:custGeom>
            <a:avLst/>
            <a:gdLst>
              <a:gd name="textAreaLeft" fmla="*/ 48960 w 76320"/>
              <a:gd name="textAreaRight" fmla="*/ 76320 w 76320"/>
              <a:gd name="textAreaTop" fmla="*/ 13680 h 533520"/>
              <a:gd name="textAreaBottom" fmla="*/ 519840 h 5335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120"/>
          <p:cNvSpPr/>
          <p:nvPr/>
        </p:nvSpPr>
        <p:spPr>
          <a:xfrm>
            <a:off x="180000" y="6299280"/>
            <a:ext cx="1015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I-enriche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122"/>
          <p:cNvSpPr/>
          <p:nvPr/>
        </p:nvSpPr>
        <p:spPr>
          <a:xfrm>
            <a:off x="4216320" y="2666880"/>
            <a:ext cx="2286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123"/>
          <p:cNvSpPr/>
          <p:nvPr/>
        </p:nvSpPr>
        <p:spPr>
          <a:xfrm>
            <a:off x="4216320" y="5486400"/>
            <a:ext cx="2286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124"/>
          <p:cNvSpPr/>
          <p:nvPr/>
        </p:nvSpPr>
        <p:spPr>
          <a:xfrm>
            <a:off x="4216320" y="5715000"/>
            <a:ext cx="2286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49"/>
          <p:cNvSpPr/>
          <p:nvPr/>
        </p:nvSpPr>
        <p:spPr>
          <a:xfrm>
            <a:off x="4479840" y="685800"/>
            <a:ext cx="67752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sGI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9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Zhikang Li</cp:lastModifiedBy>
  <dcterms:modified xsi:type="dcterms:W3CDTF">2010-12-09T09:02:40Z</dcterms:modified>
  <cp:revision>44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